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0" r:id="rId2"/>
  </p:sldIdLst>
  <p:sldSz cx="6858000" cy="9144000" type="screen4x3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5840" autoAdjust="0"/>
  </p:normalViewPr>
  <p:slideViewPr>
    <p:cSldViewPr>
      <p:cViewPr>
        <p:scale>
          <a:sx n="60" d="100"/>
          <a:sy n="60" d="100"/>
        </p:scale>
        <p:origin x="2112" y="4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8645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8D72DD-44E9-47CF-B755-24FD5FCAA12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8645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6A0BF2-3B54-4910-AAB0-3BD395A574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912892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6D4B14-732C-45D7-AC16-2CC03C63C930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1838" y="744538"/>
            <a:ext cx="2790825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AF3E77-D6B1-41E2-9DAF-613D74365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9617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>
              <a:effectLst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AF3E77-D6B1-41E2-9DAF-613D74365A4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2761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402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2604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5588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174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3751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8425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567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1141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7886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2923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2141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6B0D27-EAA5-4780-A463-204953A3D71B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6366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40" name="Straight Connector 139"/>
          <p:cNvCxnSpPr/>
          <p:nvPr/>
        </p:nvCxnSpPr>
        <p:spPr>
          <a:xfrm>
            <a:off x="1052736" y="1827182"/>
            <a:ext cx="288032" cy="144016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Oval 140"/>
          <p:cNvSpPr/>
          <p:nvPr/>
        </p:nvSpPr>
        <p:spPr>
          <a:xfrm>
            <a:off x="3717032" y="3779912"/>
            <a:ext cx="864096" cy="144016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2" name="Oval 141"/>
          <p:cNvSpPr/>
          <p:nvPr/>
        </p:nvSpPr>
        <p:spPr>
          <a:xfrm>
            <a:off x="3140968" y="899592"/>
            <a:ext cx="360040" cy="360040"/>
          </a:xfrm>
          <a:prstGeom prst="ellipse">
            <a:avLst/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3" name="Oval 142"/>
          <p:cNvSpPr/>
          <p:nvPr/>
        </p:nvSpPr>
        <p:spPr>
          <a:xfrm>
            <a:off x="2871986" y="990650"/>
            <a:ext cx="340990" cy="340990"/>
          </a:xfrm>
          <a:prstGeom prst="ellipse">
            <a:avLst/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5" name="Oval 144"/>
          <p:cNvSpPr/>
          <p:nvPr/>
        </p:nvSpPr>
        <p:spPr>
          <a:xfrm rot="5400000">
            <a:off x="1988840" y="4427984"/>
            <a:ext cx="1656184" cy="504056"/>
          </a:xfrm>
          <a:prstGeom prst="ellipse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7" name="Oval 146"/>
          <p:cNvSpPr/>
          <p:nvPr/>
        </p:nvSpPr>
        <p:spPr>
          <a:xfrm rot="5400000">
            <a:off x="2033226" y="5048434"/>
            <a:ext cx="576064" cy="402456"/>
          </a:xfrm>
          <a:prstGeom prst="ellipse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9" name="Rounded Rectangle 148"/>
          <p:cNvSpPr/>
          <p:nvPr/>
        </p:nvSpPr>
        <p:spPr>
          <a:xfrm rot="5400000">
            <a:off x="6243883" y="1630279"/>
            <a:ext cx="238043" cy="698872"/>
          </a:xfrm>
          <a:prstGeom prst="roundRect">
            <a:avLst/>
          </a:prstGeom>
          <a:solidFill>
            <a:schemeClr val="accent4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1" name="Rounded Rectangle 150"/>
          <p:cNvSpPr/>
          <p:nvPr/>
        </p:nvSpPr>
        <p:spPr>
          <a:xfrm rot="5400000">
            <a:off x="5661946" y="1787985"/>
            <a:ext cx="238045" cy="815504"/>
          </a:xfrm>
          <a:prstGeom prst="roundRect">
            <a:avLst/>
          </a:prstGeom>
          <a:solidFill>
            <a:schemeClr val="accent4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53" name="Group 152"/>
          <p:cNvGrpSpPr/>
          <p:nvPr/>
        </p:nvGrpSpPr>
        <p:grpSpPr>
          <a:xfrm>
            <a:off x="4725144" y="2339752"/>
            <a:ext cx="599844" cy="432048"/>
            <a:chOff x="4797152" y="2483768"/>
            <a:chExt cx="599844" cy="432048"/>
          </a:xfrm>
        </p:grpSpPr>
        <p:sp>
          <p:nvSpPr>
            <p:cNvPr id="155" name="Oval 154"/>
            <p:cNvSpPr/>
            <p:nvPr/>
          </p:nvSpPr>
          <p:spPr>
            <a:xfrm>
              <a:off x="4869160" y="2483768"/>
              <a:ext cx="432048" cy="43204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b="1"/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4797152" y="2555776"/>
              <a:ext cx="5998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CDC73</a:t>
              </a:r>
              <a:endParaRPr lang="en-US" sz="1200" b="1" dirty="0"/>
            </a:p>
          </p:txBody>
        </p:sp>
      </p:grpSp>
      <p:sp>
        <p:nvSpPr>
          <p:cNvPr id="158" name="TextBox 157"/>
          <p:cNvSpPr txBox="1"/>
          <p:nvPr/>
        </p:nvSpPr>
        <p:spPr>
          <a:xfrm>
            <a:off x="5502718" y="206930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AT</a:t>
            </a:r>
            <a:endParaRPr lang="en-US" sz="1200" b="1" dirty="0"/>
          </a:p>
        </p:txBody>
      </p:sp>
      <p:grpSp>
        <p:nvGrpSpPr>
          <p:cNvPr id="159" name="Group 158"/>
          <p:cNvGrpSpPr/>
          <p:nvPr/>
        </p:nvGrpSpPr>
        <p:grpSpPr>
          <a:xfrm>
            <a:off x="1772816" y="1403648"/>
            <a:ext cx="611065" cy="648072"/>
            <a:chOff x="1991676" y="1369740"/>
            <a:chExt cx="1018442" cy="360040"/>
          </a:xfrm>
        </p:grpSpPr>
        <p:sp>
          <p:nvSpPr>
            <p:cNvPr id="160" name="Oval 159"/>
            <p:cNvSpPr/>
            <p:nvPr/>
          </p:nvSpPr>
          <p:spPr>
            <a:xfrm>
              <a:off x="2132856" y="1369740"/>
              <a:ext cx="720080" cy="360040"/>
            </a:xfrm>
            <a:prstGeom prst="ellips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1991676" y="1457511"/>
              <a:ext cx="101844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Merlin</a:t>
              </a:r>
              <a:endParaRPr lang="en-US" sz="1200" b="1" dirty="0"/>
            </a:p>
          </p:txBody>
        </p:sp>
      </p:grpSp>
      <p:grpSp>
        <p:nvGrpSpPr>
          <p:cNvPr id="162" name="Group 161"/>
          <p:cNvGrpSpPr/>
          <p:nvPr/>
        </p:nvGrpSpPr>
        <p:grpSpPr>
          <a:xfrm>
            <a:off x="2708920" y="2339752"/>
            <a:ext cx="694870" cy="321940"/>
            <a:chOff x="1340768" y="1958504"/>
            <a:chExt cx="694870" cy="321940"/>
          </a:xfrm>
        </p:grpSpPr>
        <p:sp>
          <p:nvSpPr>
            <p:cNvPr id="163" name="Oval 162"/>
            <p:cNvSpPr/>
            <p:nvPr/>
          </p:nvSpPr>
          <p:spPr>
            <a:xfrm rot="5400000">
              <a:off x="1544092" y="1789088"/>
              <a:ext cx="321940" cy="660772"/>
            </a:xfrm>
            <a:prstGeom prst="ellips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1340768" y="1979712"/>
              <a:ext cx="6948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YAP/TAZ</a:t>
              </a:r>
              <a:endParaRPr lang="en-US" sz="1200" dirty="0"/>
            </a:p>
          </p:txBody>
        </p:sp>
      </p:grpSp>
      <p:grpSp>
        <p:nvGrpSpPr>
          <p:cNvPr id="165" name="Group 164"/>
          <p:cNvGrpSpPr/>
          <p:nvPr/>
        </p:nvGrpSpPr>
        <p:grpSpPr>
          <a:xfrm>
            <a:off x="2852936" y="1619672"/>
            <a:ext cx="504056" cy="360040"/>
            <a:chOff x="2204864" y="1907704"/>
            <a:chExt cx="504056" cy="360040"/>
          </a:xfrm>
        </p:grpSpPr>
        <p:sp>
          <p:nvSpPr>
            <p:cNvPr id="170" name="Oval 169"/>
            <p:cNvSpPr/>
            <p:nvPr/>
          </p:nvSpPr>
          <p:spPr>
            <a:xfrm>
              <a:off x="2204864" y="1907704"/>
              <a:ext cx="504056" cy="360040"/>
            </a:xfrm>
            <a:prstGeom prst="ellipse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2204864" y="1941612"/>
              <a:ext cx="4716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LATS</a:t>
              </a:r>
              <a:endParaRPr lang="en-US" sz="1200" dirty="0"/>
            </a:p>
          </p:txBody>
        </p:sp>
      </p:grpSp>
      <p:sp>
        <p:nvSpPr>
          <p:cNvPr id="173" name="TextBox 172"/>
          <p:cNvSpPr txBox="1"/>
          <p:nvPr/>
        </p:nvSpPr>
        <p:spPr>
          <a:xfrm>
            <a:off x="2824024" y="1043608"/>
            <a:ext cx="4609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MST</a:t>
            </a:r>
            <a:endParaRPr lang="en-US" sz="1200" dirty="0"/>
          </a:p>
        </p:txBody>
      </p:sp>
      <p:sp>
        <p:nvSpPr>
          <p:cNvPr id="174" name="TextBox 173"/>
          <p:cNvSpPr txBox="1"/>
          <p:nvPr/>
        </p:nvSpPr>
        <p:spPr>
          <a:xfrm>
            <a:off x="6021288" y="899592"/>
            <a:ext cx="3554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J</a:t>
            </a:r>
            <a:endParaRPr lang="en-US" sz="1400" b="1" dirty="0"/>
          </a:p>
        </p:txBody>
      </p:sp>
      <p:sp>
        <p:nvSpPr>
          <p:cNvPr id="175" name="TextBox 174"/>
          <p:cNvSpPr txBox="1"/>
          <p:nvPr/>
        </p:nvSpPr>
        <p:spPr>
          <a:xfrm>
            <a:off x="620688" y="1115616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TJ</a:t>
            </a:r>
            <a:endParaRPr lang="en-US" sz="1400" b="1" dirty="0"/>
          </a:p>
        </p:txBody>
      </p:sp>
      <p:grpSp>
        <p:nvGrpSpPr>
          <p:cNvPr id="176" name="Group 175"/>
          <p:cNvGrpSpPr/>
          <p:nvPr/>
        </p:nvGrpSpPr>
        <p:grpSpPr>
          <a:xfrm>
            <a:off x="1556792" y="4814242"/>
            <a:ext cx="3312368" cy="1872207"/>
            <a:chOff x="1222629" y="6187408"/>
            <a:chExt cx="4129427" cy="2529823"/>
          </a:xfrm>
        </p:grpSpPr>
        <p:sp>
          <p:nvSpPr>
            <p:cNvPr id="177" name="Freeform 176"/>
            <p:cNvSpPr/>
            <p:nvPr/>
          </p:nvSpPr>
          <p:spPr>
            <a:xfrm rot="19691139">
              <a:off x="1222629" y="6187408"/>
              <a:ext cx="3789543" cy="2467640"/>
            </a:xfrm>
            <a:custGeom>
              <a:avLst/>
              <a:gdLst>
                <a:gd name="connsiteX0" fmla="*/ 0 w 4428058"/>
                <a:gd name="connsiteY0" fmla="*/ 20739 h 3202089"/>
                <a:gd name="connsiteX1" fmla="*/ 981075 w 4428058"/>
                <a:gd name="connsiteY1" fmla="*/ 96939 h 3202089"/>
                <a:gd name="connsiteX2" fmla="*/ 1143000 w 4428058"/>
                <a:gd name="connsiteY2" fmla="*/ 782739 h 3202089"/>
                <a:gd name="connsiteX3" fmla="*/ 2038350 w 4428058"/>
                <a:gd name="connsiteY3" fmla="*/ 754164 h 3202089"/>
                <a:gd name="connsiteX4" fmla="*/ 2266950 w 4428058"/>
                <a:gd name="connsiteY4" fmla="*/ 1535214 h 3202089"/>
                <a:gd name="connsiteX5" fmla="*/ 3152775 w 4428058"/>
                <a:gd name="connsiteY5" fmla="*/ 1459014 h 3202089"/>
                <a:gd name="connsiteX6" fmla="*/ 3267075 w 4428058"/>
                <a:gd name="connsiteY6" fmla="*/ 2344839 h 3202089"/>
                <a:gd name="connsiteX7" fmla="*/ 4286250 w 4428058"/>
                <a:gd name="connsiteY7" fmla="*/ 2316264 h 3202089"/>
                <a:gd name="connsiteX8" fmla="*/ 4419600 w 4428058"/>
                <a:gd name="connsiteY8" fmla="*/ 3202089 h 3202089"/>
                <a:gd name="connsiteX9" fmla="*/ 4419600 w 4428058"/>
                <a:gd name="connsiteY9" fmla="*/ 3202089 h 32020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4428058" h="3202089">
                  <a:moveTo>
                    <a:pt x="0" y="20739"/>
                  </a:moveTo>
                  <a:cubicBezTo>
                    <a:pt x="395287" y="-4661"/>
                    <a:pt x="790575" y="-30061"/>
                    <a:pt x="981075" y="96939"/>
                  </a:cubicBezTo>
                  <a:cubicBezTo>
                    <a:pt x="1171575" y="223939"/>
                    <a:pt x="966787" y="673201"/>
                    <a:pt x="1143000" y="782739"/>
                  </a:cubicBezTo>
                  <a:cubicBezTo>
                    <a:pt x="1319213" y="892277"/>
                    <a:pt x="1851025" y="628751"/>
                    <a:pt x="2038350" y="754164"/>
                  </a:cubicBezTo>
                  <a:cubicBezTo>
                    <a:pt x="2225675" y="879577"/>
                    <a:pt x="2081213" y="1417739"/>
                    <a:pt x="2266950" y="1535214"/>
                  </a:cubicBezTo>
                  <a:cubicBezTo>
                    <a:pt x="2452687" y="1652689"/>
                    <a:pt x="2986088" y="1324077"/>
                    <a:pt x="3152775" y="1459014"/>
                  </a:cubicBezTo>
                  <a:cubicBezTo>
                    <a:pt x="3319462" y="1593951"/>
                    <a:pt x="3078163" y="2201964"/>
                    <a:pt x="3267075" y="2344839"/>
                  </a:cubicBezTo>
                  <a:cubicBezTo>
                    <a:pt x="3455987" y="2487714"/>
                    <a:pt x="4094163" y="2173389"/>
                    <a:pt x="4286250" y="2316264"/>
                  </a:cubicBezTo>
                  <a:cubicBezTo>
                    <a:pt x="4478337" y="2459139"/>
                    <a:pt x="4419600" y="3202089"/>
                    <a:pt x="4419600" y="3202089"/>
                  </a:cubicBezTo>
                  <a:lnTo>
                    <a:pt x="4419600" y="3202089"/>
                  </a:lnTo>
                </a:path>
              </a:pathLst>
            </a:cu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8" name="Freeform 177"/>
            <p:cNvSpPr/>
            <p:nvPr/>
          </p:nvSpPr>
          <p:spPr>
            <a:xfrm rot="19691139">
              <a:off x="1562513" y="6249591"/>
              <a:ext cx="3789543" cy="2467640"/>
            </a:xfrm>
            <a:custGeom>
              <a:avLst/>
              <a:gdLst>
                <a:gd name="connsiteX0" fmla="*/ 0 w 4428058"/>
                <a:gd name="connsiteY0" fmla="*/ 20739 h 3202089"/>
                <a:gd name="connsiteX1" fmla="*/ 981075 w 4428058"/>
                <a:gd name="connsiteY1" fmla="*/ 96939 h 3202089"/>
                <a:gd name="connsiteX2" fmla="*/ 1143000 w 4428058"/>
                <a:gd name="connsiteY2" fmla="*/ 782739 h 3202089"/>
                <a:gd name="connsiteX3" fmla="*/ 2038350 w 4428058"/>
                <a:gd name="connsiteY3" fmla="*/ 754164 h 3202089"/>
                <a:gd name="connsiteX4" fmla="*/ 2266950 w 4428058"/>
                <a:gd name="connsiteY4" fmla="*/ 1535214 h 3202089"/>
                <a:gd name="connsiteX5" fmla="*/ 3152775 w 4428058"/>
                <a:gd name="connsiteY5" fmla="*/ 1459014 h 3202089"/>
                <a:gd name="connsiteX6" fmla="*/ 3267075 w 4428058"/>
                <a:gd name="connsiteY6" fmla="*/ 2344839 h 3202089"/>
                <a:gd name="connsiteX7" fmla="*/ 4286250 w 4428058"/>
                <a:gd name="connsiteY7" fmla="*/ 2316264 h 3202089"/>
                <a:gd name="connsiteX8" fmla="*/ 4419600 w 4428058"/>
                <a:gd name="connsiteY8" fmla="*/ 3202089 h 3202089"/>
                <a:gd name="connsiteX9" fmla="*/ 4419600 w 4428058"/>
                <a:gd name="connsiteY9" fmla="*/ 3202089 h 32020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4428058" h="3202089">
                  <a:moveTo>
                    <a:pt x="0" y="20739"/>
                  </a:moveTo>
                  <a:cubicBezTo>
                    <a:pt x="395287" y="-4661"/>
                    <a:pt x="790575" y="-30061"/>
                    <a:pt x="981075" y="96939"/>
                  </a:cubicBezTo>
                  <a:cubicBezTo>
                    <a:pt x="1171575" y="223939"/>
                    <a:pt x="966787" y="673201"/>
                    <a:pt x="1143000" y="782739"/>
                  </a:cubicBezTo>
                  <a:cubicBezTo>
                    <a:pt x="1319213" y="892277"/>
                    <a:pt x="1851025" y="628751"/>
                    <a:pt x="2038350" y="754164"/>
                  </a:cubicBezTo>
                  <a:cubicBezTo>
                    <a:pt x="2225675" y="879577"/>
                    <a:pt x="2081213" y="1417739"/>
                    <a:pt x="2266950" y="1535214"/>
                  </a:cubicBezTo>
                  <a:cubicBezTo>
                    <a:pt x="2452687" y="1652689"/>
                    <a:pt x="2986088" y="1324077"/>
                    <a:pt x="3152775" y="1459014"/>
                  </a:cubicBezTo>
                  <a:cubicBezTo>
                    <a:pt x="3319462" y="1593951"/>
                    <a:pt x="3078163" y="2201964"/>
                    <a:pt x="3267075" y="2344839"/>
                  </a:cubicBezTo>
                  <a:cubicBezTo>
                    <a:pt x="3455987" y="2487714"/>
                    <a:pt x="4094163" y="2173389"/>
                    <a:pt x="4286250" y="2316264"/>
                  </a:cubicBezTo>
                  <a:cubicBezTo>
                    <a:pt x="4478337" y="2459139"/>
                    <a:pt x="4419600" y="3202089"/>
                    <a:pt x="4419600" y="3202089"/>
                  </a:cubicBezTo>
                  <a:lnTo>
                    <a:pt x="4419600" y="3202089"/>
                  </a:lnTo>
                </a:path>
              </a:pathLst>
            </a:cu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79" name="TextBox 178"/>
          <p:cNvSpPr txBox="1"/>
          <p:nvPr/>
        </p:nvSpPr>
        <p:spPr>
          <a:xfrm>
            <a:off x="3140968" y="5762228"/>
            <a:ext cx="2129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roliferation/Contact inhibition</a:t>
            </a:r>
          </a:p>
        </p:txBody>
      </p:sp>
      <p:grpSp>
        <p:nvGrpSpPr>
          <p:cNvPr id="180" name="Group 179"/>
          <p:cNvGrpSpPr/>
          <p:nvPr/>
        </p:nvGrpSpPr>
        <p:grpSpPr>
          <a:xfrm>
            <a:off x="5445224" y="1339291"/>
            <a:ext cx="1296144" cy="423836"/>
            <a:chOff x="512676" y="964624"/>
            <a:chExt cx="801136" cy="211918"/>
          </a:xfrm>
          <a:solidFill>
            <a:schemeClr val="accent4">
              <a:lumMod val="20000"/>
              <a:lumOff val="80000"/>
            </a:schemeClr>
          </a:solidFill>
        </p:grpSpPr>
        <p:sp>
          <p:nvSpPr>
            <p:cNvPr id="181" name="Rounded Rectangle 180"/>
            <p:cNvSpPr/>
            <p:nvPr/>
          </p:nvSpPr>
          <p:spPr>
            <a:xfrm rot="5400000">
              <a:off x="681193" y="796107"/>
              <a:ext cx="108013" cy="445047"/>
            </a:xfrm>
            <a:prstGeom prst="round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2" name="Rounded Rectangle 181"/>
            <p:cNvSpPr/>
            <p:nvPr/>
          </p:nvSpPr>
          <p:spPr>
            <a:xfrm rot="5400000">
              <a:off x="1037282" y="900012"/>
              <a:ext cx="108013" cy="445047"/>
            </a:xfrm>
            <a:prstGeom prst="round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183" name="Group 182"/>
          <p:cNvGrpSpPr/>
          <p:nvPr/>
        </p:nvGrpSpPr>
        <p:grpSpPr>
          <a:xfrm>
            <a:off x="209792" y="1552310"/>
            <a:ext cx="973005" cy="346879"/>
            <a:chOff x="5006131" y="1259632"/>
            <a:chExt cx="1303189" cy="504056"/>
          </a:xfrm>
        </p:grpSpPr>
        <p:sp>
          <p:nvSpPr>
            <p:cNvPr id="184" name="Hexagon 183"/>
            <p:cNvSpPr/>
            <p:nvPr/>
          </p:nvSpPr>
          <p:spPr>
            <a:xfrm>
              <a:off x="5006131" y="1259632"/>
              <a:ext cx="936104" cy="288033"/>
            </a:xfrm>
            <a:prstGeom prst="hexagon">
              <a:avLst/>
            </a:prstGeom>
            <a:solidFill>
              <a:schemeClr val="accent2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5" name="Hexagon 184"/>
            <p:cNvSpPr/>
            <p:nvPr/>
          </p:nvSpPr>
          <p:spPr>
            <a:xfrm>
              <a:off x="5373216" y="1475656"/>
              <a:ext cx="936104" cy="288032"/>
            </a:xfrm>
            <a:prstGeom prst="hexagon">
              <a:avLst/>
            </a:prstGeom>
            <a:solidFill>
              <a:schemeClr val="accent2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cxnSp>
        <p:nvCxnSpPr>
          <p:cNvPr id="201" name="Straight Connector 200"/>
          <p:cNvCxnSpPr/>
          <p:nvPr/>
        </p:nvCxnSpPr>
        <p:spPr>
          <a:xfrm flipV="1">
            <a:off x="4497734" y="1403648"/>
            <a:ext cx="223557" cy="149532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Connector 201"/>
          <p:cNvCxnSpPr/>
          <p:nvPr/>
        </p:nvCxnSpPr>
        <p:spPr>
          <a:xfrm flipV="1">
            <a:off x="1700808" y="1827182"/>
            <a:ext cx="144016" cy="72008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TextBox 202"/>
          <p:cNvSpPr txBox="1"/>
          <p:nvPr/>
        </p:nvSpPr>
        <p:spPr>
          <a:xfrm rot="16200000">
            <a:off x="2531840" y="4732084"/>
            <a:ext cx="5549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OL II</a:t>
            </a:r>
            <a:endParaRPr lang="en-US" sz="1200" dirty="0"/>
          </a:p>
        </p:txBody>
      </p:sp>
      <p:grpSp>
        <p:nvGrpSpPr>
          <p:cNvPr id="213" name="Group 212"/>
          <p:cNvGrpSpPr/>
          <p:nvPr/>
        </p:nvGrpSpPr>
        <p:grpSpPr>
          <a:xfrm>
            <a:off x="1899624" y="4745606"/>
            <a:ext cx="694870" cy="321940"/>
            <a:chOff x="1340768" y="1958504"/>
            <a:chExt cx="694870" cy="321940"/>
          </a:xfrm>
        </p:grpSpPr>
        <p:sp>
          <p:nvSpPr>
            <p:cNvPr id="214" name="Oval 213"/>
            <p:cNvSpPr/>
            <p:nvPr/>
          </p:nvSpPr>
          <p:spPr>
            <a:xfrm rot="5400000">
              <a:off x="1544092" y="1789088"/>
              <a:ext cx="321940" cy="660772"/>
            </a:xfrm>
            <a:prstGeom prst="ellips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1340768" y="1979712"/>
              <a:ext cx="6948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YAP/TAZ</a:t>
              </a:r>
              <a:endParaRPr lang="en-US" sz="1200" dirty="0"/>
            </a:p>
          </p:txBody>
        </p:sp>
      </p:grpSp>
      <p:grpSp>
        <p:nvGrpSpPr>
          <p:cNvPr id="216" name="Group 215"/>
          <p:cNvGrpSpPr/>
          <p:nvPr/>
        </p:nvGrpSpPr>
        <p:grpSpPr>
          <a:xfrm>
            <a:off x="1658390" y="4457574"/>
            <a:ext cx="579710" cy="360040"/>
            <a:chOff x="1484784" y="5076056"/>
            <a:chExt cx="579710" cy="360040"/>
          </a:xfrm>
        </p:grpSpPr>
        <p:sp>
          <p:nvSpPr>
            <p:cNvPr id="217" name="Oval 216"/>
            <p:cNvSpPr/>
            <p:nvPr/>
          </p:nvSpPr>
          <p:spPr>
            <a:xfrm rot="5400000">
              <a:off x="1592796" y="4968044"/>
              <a:ext cx="360040" cy="576064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1484784" y="5135364"/>
              <a:ext cx="5797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AMOT</a:t>
              </a:r>
              <a:endParaRPr lang="en-US" sz="1200" dirty="0"/>
            </a:p>
          </p:txBody>
        </p:sp>
      </p:grpSp>
      <p:grpSp>
        <p:nvGrpSpPr>
          <p:cNvPr id="226" name="Group 225"/>
          <p:cNvGrpSpPr/>
          <p:nvPr/>
        </p:nvGrpSpPr>
        <p:grpSpPr>
          <a:xfrm>
            <a:off x="1196752" y="1827182"/>
            <a:ext cx="579710" cy="360040"/>
            <a:chOff x="1484784" y="5076056"/>
            <a:chExt cx="579710" cy="360040"/>
          </a:xfrm>
        </p:grpSpPr>
        <p:sp>
          <p:nvSpPr>
            <p:cNvPr id="227" name="Oval 226"/>
            <p:cNvSpPr/>
            <p:nvPr/>
          </p:nvSpPr>
          <p:spPr>
            <a:xfrm rot="5400000">
              <a:off x="1592796" y="4968044"/>
              <a:ext cx="360040" cy="576064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9" name="TextBox 228"/>
            <p:cNvSpPr txBox="1"/>
            <p:nvPr/>
          </p:nvSpPr>
          <p:spPr>
            <a:xfrm>
              <a:off x="1484784" y="5135364"/>
              <a:ext cx="5797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AMOT</a:t>
              </a:r>
              <a:endParaRPr lang="en-US" sz="1200" dirty="0"/>
            </a:p>
          </p:txBody>
        </p:sp>
      </p:grpSp>
      <p:cxnSp>
        <p:nvCxnSpPr>
          <p:cNvPr id="234" name="Straight Connector 233"/>
          <p:cNvCxnSpPr/>
          <p:nvPr/>
        </p:nvCxnSpPr>
        <p:spPr>
          <a:xfrm flipV="1">
            <a:off x="5238583" y="2339752"/>
            <a:ext cx="162586" cy="144016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Straight Connector 234"/>
          <p:cNvCxnSpPr/>
          <p:nvPr/>
        </p:nvCxnSpPr>
        <p:spPr>
          <a:xfrm flipV="1">
            <a:off x="3068960" y="2028921"/>
            <a:ext cx="0" cy="251087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Straight Connector 235"/>
          <p:cNvCxnSpPr/>
          <p:nvPr/>
        </p:nvCxnSpPr>
        <p:spPr>
          <a:xfrm>
            <a:off x="3068960" y="1374056"/>
            <a:ext cx="0" cy="173608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Straight Connector 237"/>
          <p:cNvCxnSpPr/>
          <p:nvPr/>
        </p:nvCxnSpPr>
        <p:spPr>
          <a:xfrm flipH="1">
            <a:off x="2348880" y="1835696"/>
            <a:ext cx="393948" cy="0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0" name="Group 239"/>
          <p:cNvGrpSpPr/>
          <p:nvPr/>
        </p:nvGrpSpPr>
        <p:grpSpPr>
          <a:xfrm>
            <a:off x="3068951" y="4572000"/>
            <a:ext cx="936103" cy="720080"/>
            <a:chOff x="5085184" y="4644008"/>
            <a:chExt cx="720080" cy="720080"/>
          </a:xfrm>
        </p:grpSpPr>
        <p:grpSp>
          <p:nvGrpSpPr>
            <p:cNvPr id="242" name="Group 241"/>
            <p:cNvGrpSpPr/>
            <p:nvPr/>
          </p:nvGrpSpPr>
          <p:grpSpPr>
            <a:xfrm>
              <a:off x="5085184" y="4644008"/>
              <a:ext cx="720080" cy="720080"/>
              <a:chOff x="5085184" y="4644008"/>
              <a:chExt cx="720080" cy="720080"/>
            </a:xfrm>
          </p:grpSpPr>
          <p:sp>
            <p:nvSpPr>
              <p:cNvPr id="248" name="Oval 247"/>
              <p:cNvSpPr/>
              <p:nvPr/>
            </p:nvSpPr>
            <p:spPr>
              <a:xfrm>
                <a:off x="5085184" y="4644008"/>
                <a:ext cx="720080" cy="72008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0" name="TextBox 249"/>
              <p:cNvSpPr txBox="1"/>
              <p:nvPr/>
            </p:nvSpPr>
            <p:spPr>
              <a:xfrm>
                <a:off x="5157192" y="5004048"/>
                <a:ext cx="4941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PAFC</a:t>
                </a:r>
                <a:endParaRPr lang="en-US" sz="1200" dirty="0"/>
              </a:p>
            </p:txBody>
          </p:sp>
        </p:grpSp>
        <p:grpSp>
          <p:nvGrpSpPr>
            <p:cNvPr id="243" name="Group 242"/>
            <p:cNvGrpSpPr/>
            <p:nvPr/>
          </p:nvGrpSpPr>
          <p:grpSpPr>
            <a:xfrm>
              <a:off x="5273160" y="4644008"/>
              <a:ext cx="476713" cy="360040"/>
              <a:chOff x="4842926" y="2483768"/>
              <a:chExt cx="496392" cy="432048"/>
            </a:xfrm>
          </p:grpSpPr>
          <p:sp>
            <p:nvSpPr>
              <p:cNvPr id="245" name="Oval 244"/>
              <p:cNvSpPr/>
              <p:nvPr/>
            </p:nvSpPr>
            <p:spPr>
              <a:xfrm>
                <a:off x="4984514" y="2483768"/>
                <a:ext cx="354804" cy="432048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7" name="TextBox 246"/>
              <p:cNvSpPr txBox="1"/>
              <p:nvPr/>
            </p:nvSpPr>
            <p:spPr>
              <a:xfrm>
                <a:off x="4842926" y="2555776"/>
                <a:ext cx="483034" cy="3323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/>
                  <a:t>CDC73</a:t>
                </a:r>
                <a:endParaRPr lang="en-US" sz="1200" b="1" dirty="0"/>
              </a:p>
            </p:txBody>
          </p:sp>
        </p:grpSp>
      </p:grpSp>
      <p:grpSp>
        <p:nvGrpSpPr>
          <p:cNvPr id="251" name="Group 250"/>
          <p:cNvGrpSpPr/>
          <p:nvPr/>
        </p:nvGrpSpPr>
        <p:grpSpPr>
          <a:xfrm>
            <a:off x="3539108" y="3563888"/>
            <a:ext cx="504056" cy="360040"/>
            <a:chOff x="2204864" y="1907704"/>
            <a:chExt cx="504056" cy="360040"/>
          </a:xfrm>
        </p:grpSpPr>
        <p:sp>
          <p:nvSpPr>
            <p:cNvPr id="254" name="Oval 253"/>
            <p:cNvSpPr/>
            <p:nvPr/>
          </p:nvSpPr>
          <p:spPr>
            <a:xfrm>
              <a:off x="2204864" y="1907704"/>
              <a:ext cx="504056" cy="360040"/>
            </a:xfrm>
            <a:prstGeom prst="ellipse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5" name="TextBox 254"/>
            <p:cNvSpPr txBox="1"/>
            <p:nvPr/>
          </p:nvSpPr>
          <p:spPr>
            <a:xfrm>
              <a:off x="2204864" y="1941612"/>
              <a:ext cx="4716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LATS</a:t>
              </a:r>
              <a:endParaRPr lang="en-US" sz="1200" dirty="0"/>
            </a:p>
          </p:txBody>
        </p:sp>
      </p:grpSp>
      <p:sp>
        <p:nvSpPr>
          <p:cNvPr id="258" name="TextBox 257"/>
          <p:cNvSpPr txBox="1"/>
          <p:nvPr/>
        </p:nvSpPr>
        <p:spPr>
          <a:xfrm>
            <a:off x="2090438" y="5105646"/>
            <a:ext cx="5180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TEAD</a:t>
            </a:r>
            <a:endParaRPr lang="en-US" sz="1200" dirty="0"/>
          </a:p>
        </p:txBody>
      </p:sp>
      <p:grpSp>
        <p:nvGrpSpPr>
          <p:cNvPr id="259" name="Group 258"/>
          <p:cNvGrpSpPr/>
          <p:nvPr/>
        </p:nvGrpSpPr>
        <p:grpSpPr>
          <a:xfrm>
            <a:off x="4387964" y="4268728"/>
            <a:ext cx="490968" cy="288032"/>
            <a:chOff x="5119092" y="5652120"/>
            <a:chExt cx="490968" cy="288032"/>
          </a:xfrm>
        </p:grpSpPr>
        <p:sp>
          <p:nvSpPr>
            <p:cNvPr id="260" name="Oval 259"/>
            <p:cNvSpPr/>
            <p:nvPr/>
          </p:nvSpPr>
          <p:spPr>
            <a:xfrm>
              <a:off x="5157192" y="5652120"/>
              <a:ext cx="432048" cy="288032"/>
            </a:xfrm>
            <a:prstGeom prst="ellipse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1" name="TextBox 260"/>
            <p:cNvSpPr txBox="1"/>
            <p:nvPr/>
          </p:nvSpPr>
          <p:spPr>
            <a:xfrm>
              <a:off x="5119092" y="5652120"/>
              <a:ext cx="4909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RTF1</a:t>
              </a:r>
              <a:endParaRPr lang="en-US" sz="1200" dirty="0"/>
            </a:p>
          </p:txBody>
        </p:sp>
      </p:grpSp>
      <p:grpSp>
        <p:nvGrpSpPr>
          <p:cNvPr id="262" name="Group 261"/>
          <p:cNvGrpSpPr/>
          <p:nvPr/>
        </p:nvGrpSpPr>
        <p:grpSpPr>
          <a:xfrm>
            <a:off x="4149080" y="5004048"/>
            <a:ext cx="535724" cy="432048"/>
            <a:chOff x="3717032" y="5724128"/>
            <a:chExt cx="535724" cy="432048"/>
          </a:xfrm>
        </p:grpSpPr>
        <p:sp>
          <p:nvSpPr>
            <p:cNvPr id="268" name="Oval 267"/>
            <p:cNvSpPr/>
            <p:nvPr/>
          </p:nvSpPr>
          <p:spPr>
            <a:xfrm>
              <a:off x="3755132" y="5724128"/>
              <a:ext cx="432048" cy="432048"/>
            </a:xfrm>
            <a:prstGeom prst="ellipse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1" name="TextBox 270"/>
            <p:cNvSpPr txBox="1"/>
            <p:nvPr/>
          </p:nvSpPr>
          <p:spPr>
            <a:xfrm>
              <a:off x="3717032" y="5796136"/>
              <a:ext cx="5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HD1</a:t>
              </a:r>
              <a:endParaRPr lang="en-US" sz="1200" dirty="0"/>
            </a:p>
          </p:txBody>
        </p:sp>
      </p:grpSp>
      <p:grpSp>
        <p:nvGrpSpPr>
          <p:cNvPr id="272" name="Group 271"/>
          <p:cNvGrpSpPr/>
          <p:nvPr/>
        </p:nvGrpSpPr>
        <p:grpSpPr>
          <a:xfrm>
            <a:off x="4437112" y="4644008"/>
            <a:ext cx="1020681" cy="567680"/>
            <a:chOff x="4254996" y="5796136"/>
            <a:chExt cx="1020681" cy="567680"/>
          </a:xfrm>
        </p:grpSpPr>
        <p:grpSp>
          <p:nvGrpSpPr>
            <p:cNvPr id="275" name="Group 274"/>
            <p:cNvGrpSpPr/>
            <p:nvPr/>
          </p:nvGrpSpPr>
          <p:grpSpPr>
            <a:xfrm>
              <a:off x="4254996" y="5796136"/>
              <a:ext cx="686172" cy="567680"/>
              <a:chOff x="4254996" y="5796136"/>
              <a:chExt cx="686172" cy="567680"/>
            </a:xfrm>
          </p:grpSpPr>
          <p:sp>
            <p:nvSpPr>
              <p:cNvPr id="277" name="Oval 276"/>
              <p:cNvSpPr/>
              <p:nvPr/>
            </p:nvSpPr>
            <p:spPr>
              <a:xfrm>
                <a:off x="4293096" y="5796136"/>
                <a:ext cx="432048" cy="360040"/>
              </a:xfrm>
              <a:prstGeom prst="ellipse">
                <a:avLst/>
              </a:pr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8" name="TextBox 277"/>
              <p:cNvSpPr txBox="1"/>
              <p:nvPr/>
            </p:nvSpPr>
            <p:spPr>
              <a:xfrm>
                <a:off x="4254996" y="5811376"/>
                <a:ext cx="6198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TATSF1</a:t>
                </a:r>
                <a:endParaRPr lang="en-US" sz="1200" dirty="0"/>
              </a:p>
            </p:txBody>
          </p:sp>
          <p:sp>
            <p:nvSpPr>
              <p:cNvPr id="279" name="Oval 278"/>
              <p:cNvSpPr/>
              <p:nvPr/>
            </p:nvSpPr>
            <p:spPr>
              <a:xfrm>
                <a:off x="4509120" y="6012160"/>
                <a:ext cx="432048" cy="351656"/>
              </a:xfrm>
              <a:prstGeom prst="ellipse">
                <a:avLst/>
              </a:prstGeom>
              <a:solidFill>
                <a:schemeClr val="bg2">
                  <a:lumMod val="9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76" name="TextBox 275"/>
            <p:cNvSpPr txBox="1"/>
            <p:nvPr/>
          </p:nvSpPr>
          <p:spPr>
            <a:xfrm>
              <a:off x="4509120" y="6084168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U2snRNP</a:t>
              </a:r>
              <a:endParaRPr lang="en-US" sz="1200" dirty="0"/>
            </a:p>
          </p:txBody>
        </p:sp>
      </p:grpSp>
      <p:cxnSp>
        <p:nvCxnSpPr>
          <p:cNvPr id="280" name="Straight Connector 279"/>
          <p:cNvCxnSpPr/>
          <p:nvPr/>
        </p:nvCxnSpPr>
        <p:spPr>
          <a:xfrm>
            <a:off x="4293096" y="1547664"/>
            <a:ext cx="0" cy="252028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Straight Connector 280"/>
          <p:cNvCxnSpPr/>
          <p:nvPr/>
        </p:nvCxnSpPr>
        <p:spPr>
          <a:xfrm>
            <a:off x="5085184" y="5433848"/>
            <a:ext cx="72008" cy="144016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2" name="TextBox 281"/>
          <p:cNvSpPr txBox="1"/>
          <p:nvPr/>
        </p:nvSpPr>
        <p:spPr>
          <a:xfrm>
            <a:off x="3861048" y="4355976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Merlin</a:t>
            </a:r>
            <a:endParaRPr lang="en-US" sz="1200" b="1" dirty="0"/>
          </a:p>
        </p:txBody>
      </p:sp>
      <p:cxnSp>
        <p:nvCxnSpPr>
          <p:cNvPr id="284" name="Straight Arrow Connector 283"/>
          <p:cNvCxnSpPr/>
          <p:nvPr/>
        </p:nvCxnSpPr>
        <p:spPr>
          <a:xfrm flipV="1">
            <a:off x="3573016" y="3923928"/>
            <a:ext cx="72008" cy="216024"/>
          </a:xfrm>
          <a:prstGeom prst="straightConnector1">
            <a:avLst/>
          </a:prstGeom>
          <a:ln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5" name="Straight Arrow Connector 284"/>
          <p:cNvCxnSpPr/>
          <p:nvPr/>
        </p:nvCxnSpPr>
        <p:spPr>
          <a:xfrm>
            <a:off x="3573016" y="4427984"/>
            <a:ext cx="52968" cy="175424"/>
          </a:xfrm>
          <a:prstGeom prst="straightConnector1">
            <a:avLst/>
          </a:prstGeom>
          <a:ln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7" name="Straight Arrow Connector 286"/>
          <p:cNvCxnSpPr/>
          <p:nvPr/>
        </p:nvCxnSpPr>
        <p:spPr>
          <a:xfrm flipH="1">
            <a:off x="3203451" y="4408934"/>
            <a:ext cx="144016" cy="144016"/>
          </a:xfrm>
          <a:prstGeom prst="straightConnector1">
            <a:avLst/>
          </a:prstGeom>
          <a:ln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88" name="Group 287"/>
          <p:cNvGrpSpPr/>
          <p:nvPr/>
        </p:nvGrpSpPr>
        <p:grpSpPr>
          <a:xfrm>
            <a:off x="4005064" y="1403648"/>
            <a:ext cx="611065" cy="648072"/>
            <a:chOff x="1991676" y="1369740"/>
            <a:chExt cx="1018442" cy="360040"/>
          </a:xfrm>
        </p:grpSpPr>
        <p:sp>
          <p:nvSpPr>
            <p:cNvPr id="289" name="Oval 288"/>
            <p:cNvSpPr/>
            <p:nvPr/>
          </p:nvSpPr>
          <p:spPr>
            <a:xfrm>
              <a:off x="2132856" y="1369740"/>
              <a:ext cx="720080" cy="360040"/>
            </a:xfrm>
            <a:prstGeom prst="ellips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90" name="TextBox 289"/>
            <p:cNvSpPr txBox="1"/>
            <p:nvPr/>
          </p:nvSpPr>
          <p:spPr>
            <a:xfrm>
              <a:off x="1991676" y="1457511"/>
              <a:ext cx="101844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Merlin</a:t>
              </a:r>
              <a:endParaRPr lang="en-US" sz="1200" b="1" dirty="0"/>
            </a:p>
          </p:txBody>
        </p:sp>
      </p:grpSp>
      <p:cxnSp>
        <p:nvCxnSpPr>
          <p:cNvPr id="292" name="Straight Connector 291"/>
          <p:cNvCxnSpPr/>
          <p:nvPr/>
        </p:nvCxnSpPr>
        <p:spPr>
          <a:xfrm flipH="1">
            <a:off x="3818068" y="2662328"/>
            <a:ext cx="1008112" cy="193870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3" name="Group 292"/>
          <p:cNvGrpSpPr/>
          <p:nvPr/>
        </p:nvGrpSpPr>
        <p:grpSpPr>
          <a:xfrm>
            <a:off x="2924944" y="5652120"/>
            <a:ext cx="288032" cy="216024"/>
            <a:chOff x="2852936" y="7102100"/>
            <a:chExt cx="432048" cy="206204"/>
          </a:xfrm>
        </p:grpSpPr>
        <p:cxnSp>
          <p:nvCxnSpPr>
            <p:cNvPr id="294" name="Straight Connector 293"/>
            <p:cNvCxnSpPr/>
            <p:nvPr/>
          </p:nvCxnSpPr>
          <p:spPr>
            <a:xfrm flipV="1">
              <a:off x="2860556" y="7102100"/>
              <a:ext cx="0" cy="196385"/>
            </a:xfrm>
            <a:prstGeom prst="line">
              <a:avLst/>
            </a:prstGeom>
            <a:ln w="1905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Straight Arrow Connector 294"/>
            <p:cNvCxnSpPr/>
            <p:nvPr/>
          </p:nvCxnSpPr>
          <p:spPr>
            <a:xfrm>
              <a:off x="2852936" y="7308304"/>
              <a:ext cx="43204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8" name="Oval 297"/>
          <p:cNvSpPr/>
          <p:nvPr/>
        </p:nvSpPr>
        <p:spPr>
          <a:xfrm>
            <a:off x="1124744" y="3563888"/>
            <a:ext cx="4752528" cy="2592288"/>
          </a:xfrm>
          <a:prstGeom prst="ellipse">
            <a:avLst/>
          </a:prstGeom>
          <a:noFill/>
          <a:ln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9" name="Rounded Rectangle 298"/>
          <p:cNvSpPr/>
          <p:nvPr/>
        </p:nvSpPr>
        <p:spPr>
          <a:xfrm>
            <a:off x="980728" y="755576"/>
            <a:ext cx="4968552" cy="5544616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01" name="Straight Connector 300"/>
          <p:cNvCxnSpPr>
            <a:endCxn id="181" idx="2"/>
          </p:cNvCxnSpPr>
          <p:nvPr/>
        </p:nvCxnSpPr>
        <p:spPr>
          <a:xfrm>
            <a:off x="5157192" y="1403648"/>
            <a:ext cx="288032" cy="43656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3" name="Group 302"/>
          <p:cNvGrpSpPr/>
          <p:nvPr/>
        </p:nvGrpSpPr>
        <p:grpSpPr>
          <a:xfrm>
            <a:off x="4653136" y="1187624"/>
            <a:ext cx="797141" cy="288032"/>
            <a:chOff x="4797152" y="539552"/>
            <a:chExt cx="797141" cy="288032"/>
          </a:xfrm>
        </p:grpSpPr>
        <p:sp>
          <p:nvSpPr>
            <p:cNvPr id="305" name="Oval 304"/>
            <p:cNvSpPr/>
            <p:nvPr/>
          </p:nvSpPr>
          <p:spPr>
            <a:xfrm>
              <a:off x="4797152" y="539552"/>
              <a:ext cx="792088" cy="288032"/>
            </a:xfrm>
            <a:prstGeom prst="ellipse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07" name="TextBox 306"/>
            <p:cNvSpPr txBox="1"/>
            <p:nvPr/>
          </p:nvSpPr>
          <p:spPr>
            <a:xfrm>
              <a:off x="4797152" y="539552"/>
              <a:ext cx="7971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A-Catenin</a:t>
              </a:r>
              <a:endParaRPr lang="en-US" sz="1200" dirty="0"/>
            </a:p>
          </p:txBody>
        </p:sp>
      </p:grpSp>
      <p:cxnSp>
        <p:nvCxnSpPr>
          <p:cNvPr id="309" name="Straight Arrow Connector 308"/>
          <p:cNvCxnSpPr/>
          <p:nvPr/>
        </p:nvCxnSpPr>
        <p:spPr>
          <a:xfrm>
            <a:off x="2564904" y="971600"/>
            <a:ext cx="216024" cy="144016"/>
          </a:xfrm>
          <a:prstGeom prst="straightConnector1">
            <a:avLst/>
          </a:prstGeom>
          <a:ln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1" name="Rectangle 310"/>
          <p:cNvSpPr/>
          <p:nvPr/>
        </p:nvSpPr>
        <p:spPr>
          <a:xfrm>
            <a:off x="4941168" y="107504"/>
            <a:ext cx="168828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Roehrig_</a:t>
            </a:r>
            <a:r>
              <a:rPr lang="en-GB" sz="1600" b="1">
                <a:latin typeface="Arial" panose="020B0604020202020204" pitchFamily="34" charset="0"/>
                <a:cs typeface="Arial" panose="020B0604020202020204" pitchFamily="34" charset="0"/>
              </a:rPr>
              <a:t>S7 Fig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2" name="Straight Arrow Connector 311"/>
          <p:cNvCxnSpPr/>
          <p:nvPr/>
        </p:nvCxnSpPr>
        <p:spPr>
          <a:xfrm flipV="1">
            <a:off x="3833413" y="4320744"/>
            <a:ext cx="192125" cy="9708"/>
          </a:xfrm>
          <a:prstGeom prst="straightConnector1">
            <a:avLst/>
          </a:prstGeom>
          <a:ln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3" name="Group 312"/>
          <p:cNvGrpSpPr/>
          <p:nvPr/>
        </p:nvGrpSpPr>
        <p:grpSpPr>
          <a:xfrm>
            <a:off x="3212976" y="4113664"/>
            <a:ext cx="768159" cy="360040"/>
            <a:chOff x="3789040" y="3389392"/>
            <a:chExt cx="768159" cy="360040"/>
          </a:xfrm>
        </p:grpSpPr>
        <p:sp>
          <p:nvSpPr>
            <p:cNvPr id="314" name="Oval 313"/>
            <p:cNvSpPr/>
            <p:nvPr/>
          </p:nvSpPr>
          <p:spPr>
            <a:xfrm>
              <a:off x="3861048" y="3389392"/>
              <a:ext cx="576064" cy="36004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5" name="Rectangle 314"/>
            <p:cNvSpPr/>
            <p:nvPr/>
          </p:nvSpPr>
          <p:spPr>
            <a:xfrm>
              <a:off x="3789040" y="3419872"/>
              <a:ext cx="76815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/>
                <a:t>CRL4</a:t>
              </a:r>
              <a:r>
                <a:rPr lang="en-GB" sz="1200" baseline="30000" dirty="0"/>
                <a:t>VPRBP</a:t>
              </a:r>
              <a:endParaRPr lang="en-GB" sz="1200" dirty="0"/>
            </a:p>
          </p:txBody>
        </p:sp>
      </p:grpSp>
      <p:cxnSp>
        <p:nvCxnSpPr>
          <p:cNvPr id="316" name="Straight Connector 315"/>
          <p:cNvCxnSpPr>
            <a:endCxn id="214" idx="2"/>
          </p:cNvCxnSpPr>
          <p:nvPr/>
        </p:nvCxnSpPr>
        <p:spPr>
          <a:xfrm flipH="1">
            <a:off x="2263918" y="2699792"/>
            <a:ext cx="517010" cy="2045814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143"/>
          <p:cNvCxnSpPr/>
          <p:nvPr/>
        </p:nvCxnSpPr>
        <p:spPr>
          <a:xfrm flipH="1">
            <a:off x="3455185" y="1835696"/>
            <a:ext cx="523695" cy="0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Connector 145"/>
          <p:cNvCxnSpPr/>
          <p:nvPr/>
        </p:nvCxnSpPr>
        <p:spPr>
          <a:xfrm>
            <a:off x="1772816" y="2123728"/>
            <a:ext cx="864096" cy="216024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Arrow Connector 147"/>
          <p:cNvCxnSpPr/>
          <p:nvPr/>
        </p:nvCxnSpPr>
        <p:spPr>
          <a:xfrm flipH="1">
            <a:off x="3573016" y="971600"/>
            <a:ext cx="144016" cy="144016"/>
          </a:xfrm>
          <a:prstGeom prst="straightConnector1">
            <a:avLst/>
          </a:prstGeom>
          <a:ln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2" name="Group 151"/>
          <p:cNvGrpSpPr/>
          <p:nvPr/>
        </p:nvGrpSpPr>
        <p:grpSpPr>
          <a:xfrm>
            <a:off x="3140968" y="1403648"/>
            <a:ext cx="502061" cy="360040"/>
            <a:chOff x="2204864" y="1907704"/>
            <a:chExt cx="585738" cy="360040"/>
          </a:xfrm>
        </p:grpSpPr>
        <p:sp>
          <p:nvSpPr>
            <p:cNvPr id="154" name="Oval 153"/>
            <p:cNvSpPr/>
            <p:nvPr/>
          </p:nvSpPr>
          <p:spPr>
            <a:xfrm>
              <a:off x="2204864" y="1907704"/>
              <a:ext cx="504056" cy="360040"/>
            </a:xfrm>
            <a:prstGeom prst="ellipse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2204864" y="1941612"/>
              <a:ext cx="5857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MOB</a:t>
              </a:r>
              <a:endParaRPr lang="en-US" sz="1200" dirty="0"/>
            </a:p>
          </p:txBody>
        </p:sp>
      </p:grpSp>
      <p:sp>
        <p:nvSpPr>
          <p:cNvPr id="167" name="TextBox 166"/>
          <p:cNvSpPr txBox="1"/>
          <p:nvPr/>
        </p:nvSpPr>
        <p:spPr>
          <a:xfrm>
            <a:off x="3140968" y="971600"/>
            <a:ext cx="423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V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14083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67</TotalTime>
  <Words>40</Words>
  <Application>Microsoft Office PowerPoint</Application>
  <PresentationFormat>On-screen Show (4:3)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blo Rodriguez-Viciana</dc:creator>
  <cp:lastModifiedBy>chn off29</cp:lastModifiedBy>
  <cp:revision>313</cp:revision>
  <cp:lastPrinted>2016-11-23T15:50:56Z</cp:lastPrinted>
  <dcterms:created xsi:type="dcterms:W3CDTF">2013-05-02T15:08:20Z</dcterms:created>
  <dcterms:modified xsi:type="dcterms:W3CDTF">2021-07-20T03:26:51Z</dcterms:modified>
</cp:coreProperties>
</file>